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51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91439" cy="91439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090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00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9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240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497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480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930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038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393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842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113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56078-C121-4F5D-8841-1F3314AEC3B0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BAB9A7-8D37-4503-8AB5-9C5E8FA02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313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619598" y="766128"/>
            <a:ext cx="7977683" cy="5189585"/>
            <a:chOff x="619598" y="766128"/>
            <a:chExt cx="7977683" cy="5189585"/>
          </a:xfrm>
        </p:grpSpPr>
        <p:sp>
          <p:nvSpPr>
            <p:cNvPr id="3" name="Rectangle 2"/>
            <p:cNvSpPr/>
            <p:nvPr/>
          </p:nvSpPr>
          <p:spPr>
            <a:xfrm>
              <a:off x="5846139" y="3682622"/>
              <a:ext cx="91440" cy="91440"/>
            </a:xfrm>
            <a:prstGeom prst="rect">
              <a:avLst/>
            </a:prstGeom>
            <a:solidFill>
              <a:srgbClr val="7030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5835954" y="1031695"/>
              <a:ext cx="91440" cy="91440"/>
            </a:xfrm>
            <a:prstGeom prst="rect">
              <a:avLst/>
            </a:prstGeom>
            <a:solidFill>
              <a:srgbClr val="7030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9447" y="1048014"/>
              <a:ext cx="2612718" cy="2253276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39447" y="771015"/>
              <a:ext cx="13019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Random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alk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17207" y="1048014"/>
              <a:ext cx="2609151" cy="2255829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3317207" y="771015"/>
              <a:ext cx="13479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 Attractant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nl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00023" y="1048014"/>
              <a:ext cx="2597258" cy="225327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6000023" y="766128"/>
              <a:ext cx="20265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. Repellent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no resistanc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9447" y="3684653"/>
              <a:ext cx="2612718" cy="226758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619598" y="3407654"/>
              <a:ext cx="20681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. Repellent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d resistanc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17207" y="3675292"/>
              <a:ext cx="2635024" cy="2276941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3317207" y="3398293"/>
              <a:ext cx="278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. Repellent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attractant and resistanc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Oval 25"/>
            <p:cNvSpPr/>
            <p:nvPr/>
          </p:nvSpPr>
          <p:spPr>
            <a:xfrm>
              <a:off x="5842843" y="1043127"/>
              <a:ext cx="73152" cy="73152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Oval 27"/>
            <p:cNvSpPr/>
            <p:nvPr/>
          </p:nvSpPr>
          <p:spPr>
            <a:xfrm>
              <a:off x="6814861" y="3197523"/>
              <a:ext cx="73152" cy="73152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Oval 28"/>
            <p:cNvSpPr/>
            <p:nvPr/>
          </p:nvSpPr>
          <p:spPr>
            <a:xfrm>
              <a:off x="5853206" y="3695350"/>
              <a:ext cx="73152" cy="73152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Oval 29"/>
            <p:cNvSpPr/>
            <p:nvPr/>
          </p:nvSpPr>
          <p:spPr>
            <a:xfrm>
              <a:off x="1732928" y="1472567"/>
              <a:ext cx="73152" cy="73152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Oval 30"/>
            <p:cNvSpPr/>
            <p:nvPr/>
          </p:nvSpPr>
          <p:spPr>
            <a:xfrm>
              <a:off x="1771574" y="4947423"/>
              <a:ext cx="73152" cy="73152"/>
            </a:xfrm>
            <a:prstGeom prst="ellips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Oval 31"/>
            <p:cNvSpPr/>
            <p:nvPr/>
          </p:nvSpPr>
          <p:spPr>
            <a:xfrm>
              <a:off x="1903103" y="4770630"/>
              <a:ext cx="73152" cy="73152"/>
            </a:xfrm>
            <a:prstGeom prst="ellipse">
              <a:avLst/>
            </a:prstGeom>
            <a:solidFill>
              <a:srgbClr val="0000FF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0" name="Group 39"/>
            <p:cNvGrpSpPr/>
            <p:nvPr/>
          </p:nvGrpSpPr>
          <p:grpSpPr>
            <a:xfrm>
              <a:off x="6500800" y="4308572"/>
              <a:ext cx="1372278" cy="530783"/>
              <a:chOff x="6631636" y="3875641"/>
              <a:chExt cx="1372278" cy="530783"/>
            </a:xfrm>
          </p:grpSpPr>
          <p:sp>
            <p:nvSpPr>
              <p:cNvPr id="25" name="Oval 24"/>
              <p:cNvSpPr/>
              <p:nvPr/>
            </p:nvSpPr>
            <p:spPr>
              <a:xfrm>
                <a:off x="6631636" y="3964940"/>
                <a:ext cx="73152" cy="73152"/>
              </a:xfrm>
              <a:prstGeom prst="ellipse">
                <a:avLst/>
              </a:prstGeom>
              <a:solidFill>
                <a:srgbClr val="0000FF"/>
              </a:solidFill>
              <a:ln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Oval 26"/>
              <p:cNvSpPr/>
              <p:nvPr/>
            </p:nvSpPr>
            <p:spPr>
              <a:xfrm>
                <a:off x="6631636" y="4217175"/>
                <a:ext cx="73152" cy="7315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764472" y="3875641"/>
                <a:ext cx="12394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ginning point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6764472" y="4129425"/>
                <a:ext cx="10358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nding point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6471174" y="5195190"/>
              <a:ext cx="1123890" cy="760523"/>
              <a:chOff x="6471174" y="4433500"/>
              <a:chExt cx="1123890" cy="760523"/>
            </a:xfrm>
          </p:grpSpPr>
          <p:cxnSp>
            <p:nvCxnSpPr>
              <p:cNvPr id="21" name="Straight Connector 20"/>
              <p:cNvCxnSpPr/>
              <p:nvPr/>
            </p:nvCxnSpPr>
            <p:spPr>
              <a:xfrm>
                <a:off x="6471174" y="4572000"/>
                <a:ext cx="293298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6471174" y="4819291"/>
                <a:ext cx="293298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6471174" y="5034951"/>
                <a:ext cx="293298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6764472" y="4433500"/>
                <a:ext cx="7312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– 10 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6757553" y="4675262"/>
                <a:ext cx="8048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 – 30 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6778815" y="4917024"/>
                <a:ext cx="81624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1 – 60 s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6395082" y="4027681"/>
              <a:ext cx="13773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squito locatio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395082" y="4925898"/>
              <a:ext cx="1608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ying path by period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6503280" y="3641617"/>
              <a:ext cx="91440" cy="91440"/>
            </a:xfrm>
            <a:prstGeom prst="rect">
              <a:avLst/>
            </a:prstGeom>
            <a:solidFill>
              <a:srgbClr val="7030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628596" y="3558795"/>
              <a:ext cx="181633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tractant/repellent release poin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8504516" y="1043127"/>
              <a:ext cx="91440" cy="91440"/>
            </a:xfrm>
            <a:prstGeom prst="rect">
              <a:avLst/>
            </a:prstGeom>
            <a:solidFill>
              <a:srgbClr val="7030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3120616" y="3698187"/>
              <a:ext cx="91440" cy="91440"/>
            </a:xfrm>
            <a:prstGeom prst="rect">
              <a:avLst/>
            </a:prstGeom>
            <a:solidFill>
              <a:srgbClr val="7030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346804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7</TotalTime>
  <Words>51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Guofa</dc:creator>
  <cp:lastModifiedBy>Zhou, Guofa</cp:lastModifiedBy>
  <cp:revision>17</cp:revision>
  <dcterms:created xsi:type="dcterms:W3CDTF">2020-03-06T18:14:50Z</dcterms:created>
  <dcterms:modified xsi:type="dcterms:W3CDTF">2020-03-09T21:01:10Z</dcterms:modified>
</cp:coreProperties>
</file>